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0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Rstr\baisakh\nbaisakh\Desktop\Research%20projects\Sugarcane\Leafscald\QTL%20manuscript\Final%20QTL\Allelic%20composition%20and%20error%20bars\LSqPCR2017\c1-586bMerist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Rstr\baisakh\nbaisakh\Desktop\Research%20projects\Sugarcane\Leafscald\QTL%20manuscript\Final%20QTL\Allelic%20composition%20and%20error%20bars\LSqPCR2017\Sb05g340Merist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Rstr\baisakh\nbaisakh\Desktop\Research%20projects\Sugarcane\Leafscald\QTL%20manuscript\Final%20QTL\Allelic%20composition%20and%20error%20bars\LSqPCR2017\Sb03g810Leave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34951881014874"/>
          <c:y val="5.0925925925925923E-2"/>
          <c:w val="0.80332414698162735"/>
          <c:h val="0.74439012831729368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[c1-586bMerist.xls]Mean'!$K$42</c:f>
              <c:strCache>
                <c:ptCount val="1"/>
                <c:pt idx="0">
                  <c:v>HoCP 85-84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[c1-586bMerist.xls]Mean'!$D$25:$D$28</c:f>
                <c:numCache>
                  <c:formatCode>General</c:formatCode>
                  <c:ptCount val="4"/>
                  <c:pt idx="0">
                    <c:v>0.18547424906330612</c:v>
                  </c:pt>
                  <c:pt idx="1">
                    <c:v>0.43357011811487212</c:v>
                  </c:pt>
                  <c:pt idx="2">
                    <c:v>0.4947465238039071</c:v>
                  </c:pt>
                  <c:pt idx="3">
                    <c:v>0.41717100346588049</c:v>
                  </c:pt>
                </c:numCache>
              </c:numRef>
            </c:plus>
          </c:errBars>
          <c:cat>
            <c:strRef>
              <c:f>'[c1-586bMerist.xls]Mean'!$L$41:$O$41</c:f>
              <c:strCache>
                <c:ptCount val="4"/>
                <c:pt idx="0">
                  <c:v>24 h</c:v>
                </c:pt>
                <c:pt idx="1">
                  <c:v>48 h</c:v>
                </c:pt>
                <c:pt idx="2">
                  <c:v>72 h</c:v>
                </c:pt>
                <c:pt idx="3">
                  <c:v>1 wk</c:v>
                </c:pt>
              </c:strCache>
            </c:strRef>
          </c:cat>
          <c:val>
            <c:numRef>
              <c:f>'[c1-586bMerist.xls]Mean'!$L$42:$O$42</c:f>
              <c:numCache>
                <c:formatCode>General</c:formatCode>
                <c:ptCount val="4"/>
                <c:pt idx="0">
                  <c:v>1.9719968765753491</c:v>
                </c:pt>
                <c:pt idx="1">
                  <c:v>0.65116963099752623</c:v>
                </c:pt>
                <c:pt idx="2">
                  <c:v>2.4473629182253891</c:v>
                </c:pt>
                <c:pt idx="3">
                  <c:v>1.3864423867912463</c:v>
                </c:pt>
              </c:numCache>
            </c:numRef>
          </c:val>
        </c:ser>
        <c:ser>
          <c:idx val="3"/>
          <c:order val="1"/>
          <c:tx>
            <c:strRef>
              <c:f>'[c1-586bMerist.xls]Mean'!$K$43</c:f>
              <c:strCache>
                <c:ptCount val="1"/>
                <c:pt idx="0">
                  <c:v>LCP 85-384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[c1-586bMerist.xls]Mean'!$D$33:$D$36</c:f>
                <c:numCache>
                  <c:formatCode>General</c:formatCode>
                  <c:ptCount val="4"/>
                  <c:pt idx="0">
                    <c:v>0.36537449009968131</c:v>
                  </c:pt>
                  <c:pt idx="1">
                    <c:v>0.39983196011051891</c:v>
                  </c:pt>
                  <c:pt idx="2">
                    <c:v>0.4348673666521537</c:v>
                  </c:pt>
                  <c:pt idx="3">
                    <c:v>0.29257992253474946</c:v>
                  </c:pt>
                </c:numCache>
              </c:numRef>
            </c:plus>
          </c:errBars>
          <c:cat>
            <c:strRef>
              <c:f>'[c1-586bMerist.xls]Mean'!$L$41:$O$41</c:f>
              <c:strCache>
                <c:ptCount val="4"/>
                <c:pt idx="0">
                  <c:v>24 h</c:v>
                </c:pt>
                <c:pt idx="1">
                  <c:v>48 h</c:v>
                </c:pt>
                <c:pt idx="2">
                  <c:v>72 h</c:v>
                </c:pt>
                <c:pt idx="3">
                  <c:v>1 wk</c:v>
                </c:pt>
              </c:strCache>
            </c:strRef>
          </c:cat>
          <c:val>
            <c:numRef>
              <c:f>'[c1-586bMerist.xls]Mean'!$L$43:$O$43</c:f>
              <c:numCache>
                <c:formatCode>General</c:formatCode>
                <c:ptCount val="4"/>
                <c:pt idx="0">
                  <c:v>1.0676262454860896</c:v>
                </c:pt>
                <c:pt idx="1">
                  <c:v>1.8370811604936719</c:v>
                </c:pt>
                <c:pt idx="2">
                  <c:v>5.9783101583774974</c:v>
                </c:pt>
                <c:pt idx="3">
                  <c:v>0.630466307394804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4968448"/>
        <c:axId val="95023872"/>
      </c:barChart>
      <c:catAx>
        <c:axId val="949684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after inocula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5023872"/>
        <c:crosses val="autoZero"/>
        <c:auto val="1"/>
        <c:lblAlgn val="ctr"/>
        <c:lblOffset val="100"/>
        <c:noMultiLvlLbl val="0"/>
      </c:catAx>
      <c:valAx>
        <c:axId val="950238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49684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2878477690288718"/>
          <c:y val="0.19878135024788568"/>
          <c:w val="0.32281091193388062"/>
          <c:h val="0.1579928550597841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790529308836397"/>
          <c:y val="5.1400554097404488E-2"/>
          <c:w val="0.81329680664916881"/>
          <c:h val="0.73444808982210552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[Sb05g340Merist.xls]Mean!$G$2</c:f>
              <c:strCache>
                <c:ptCount val="1"/>
                <c:pt idx="0">
                  <c:v>HoCP 85-84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Sb05g340Merist.xls]Mean!$D$25:$D$28</c:f>
                <c:numCache>
                  <c:formatCode>General</c:formatCode>
                  <c:ptCount val="4"/>
                  <c:pt idx="0">
                    <c:v>0.8708441428790884</c:v>
                  </c:pt>
                  <c:pt idx="1">
                    <c:v>0.23579826093819181</c:v>
                  </c:pt>
                  <c:pt idx="2">
                    <c:v>0.30767249676781944</c:v>
                  </c:pt>
                  <c:pt idx="3">
                    <c:v>0.47681736059124541</c:v>
                  </c:pt>
                </c:numCache>
              </c:numRef>
            </c:plus>
          </c:errBars>
          <c:cat>
            <c:strRef>
              <c:f>[Sb05g340Merist.xls]Mean!$H$1:$K$1</c:f>
              <c:strCache>
                <c:ptCount val="4"/>
                <c:pt idx="0">
                  <c:v>24 h</c:v>
                </c:pt>
                <c:pt idx="1">
                  <c:v>48 h</c:v>
                </c:pt>
                <c:pt idx="2">
                  <c:v>72 h</c:v>
                </c:pt>
                <c:pt idx="3">
                  <c:v>1 wk</c:v>
                </c:pt>
              </c:strCache>
            </c:strRef>
          </c:cat>
          <c:val>
            <c:numRef>
              <c:f>[Sb05g340Merist.xls]Mean!$H$2:$K$2</c:f>
              <c:numCache>
                <c:formatCode>General</c:formatCode>
                <c:ptCount val="4"/>
                <c:pt idx="0">
                  <c:v>3.2620159995470126</c:v>
                </c:pt>
                <c:pt idx="1">
                  <c:v>0.33063373167706361</c:v>
                </c:pt>
                <c:pt idx="2">
                  <c:v>1.0131795832495167</c:v>
                </c:pt>
                <c:pt idx="3">
                  <c:v>5.6131036617671499E-2</c:v>
                </c:pt>
              </c:numCache>
            </c:numRef>
          </c:val>
        </c:ser>
        <c:ser>
          <c:idx val="3"/>
          <c:order val="1"/>
          <c:tx>
            <c:strRef>
              <c:f>[Sb05g340Merist.xls]Mean!$G$3</c:f>
              <c:strCache>
                <c:ptCount val="1"/>
                <c:pt idx="0">
                  <c:v>LCP 85-384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</c:errBars>
          <c:cat>
            <c:strRef>
              <c:f>[Sb05g340Merist.xls]Mean!$H$1:$K$1</c:f>
              <c:strCache>
                <c:ptCount val="4"/>
                <c:pt idx="0">
                  <c:v>24 h</c:v>
                </c:pt>
                <c:pt idx="1">
                  <c:v>48 h</c:v>
                </c:pt>
                <c:pt idx="2">
                  <c:v>72 h</c:v>
                </c:pt>
                <c:pt idx="3">
                  <c:v>1 wk</c:v>
                </c:pt>
              </c:strCache>
            </c:strRef>
          </c:cat>
          <c:val>
            <c:numRef>
              <c:f>[Sb05g340Merist.xls]Mean!$H$3:$K$3</c:f>
              <c:numCache>
                <c:formatCode>General</c:formatCode>
                <c:ptCount val="4"/>
                <c:pt idx="0">
                  <c:v>1.2113335324654315</c:v>
                </c:pt>
                <c:pt idx="1">
                  <c:v>2.073967894293165</c:v>
                </c:pt>
                <c:pt idx="2">
                  <c:v>3.0037989828150624</c:v>
                </c:pt>
                <c:pt idx="3">
                  <c:v>1.87193054208675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648000"/>
        <c:axId val="95654272"/>
      </c:barChart>
      <c:catAx>
        <c:axId val="956480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ime after inoculation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95654272"/>
        <c:crosses val="autoZero"/>
        <c:auto val="1"/>
        <c:lblAlgn val="ctr"/>
        <c:lblOffset val="100"/>
        <c:noMultiLvlLbl val="0"/>
      </c:catAx>
      <c:valAx>
        <c:axId val="956542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956480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9009098862642158"/>
          <c:y val="7.3529819189268014E-2"/>
          <c:w val="0.43422346299334019"/>
          <c:h val="0.15849591717701955"/>
        </c:manualLayout>
      </c:layout>
      <c:overlay val="0"/>
      <c:txPr>
        <a:bodyPr/>
        <a:lstStyle/>
        <a:p>
          <a:pPr>
            <a:defRPr sz="1000" b="0" i="0" u="none" strike="noStrike" baseline="0">
              <a:solidFill>
                <a:srgbClr val="000000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979396325459316"/>
          <c:y val="5.0925925925925923E-2"/>
          <c:w val="0.81542047188354705"/>
          <c:h val="0.74439012831729368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[Sb03g810Leaves.xls]Mean!$G$2</c:f>
              <c:strCache>
                <c:ptCount val="1"/>
                <c:pt idx="0">
                  <c:v>HoCP 85-84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Sb03g810Leaves.xls]Mean!$D$25:$D$28</c:f>
                <c:numCache>
                  <c:formatCode>General</c:formatCode>
                  <c:ptCount val="4"/>
                  <c:pt idx="0">
                    <c:v>0.89663155611174739</c:v>
                  </c:pt>
                  <c:pt idx="1">
                    <c:v>0.16568068334356192</c:v>
                  </c:pt>
                  <c:pt idx="2">
                    <c:v>0.6683357294981711</c:v>
                  </c:pt>
                  <c:pt idx="3">
                    <c:v>1.5216562142348222</c:v>
                  </c:pt>
                </c:numCache>
              </c:numRef>
            </c:plus>
          </c:errBars>
          <c:cat>
            <c:strRef>
              <c:f>[Sb03g810Leaves.xls]Mean!$H$1:$K$1</c:f>
              <c:strCache>
                <c:ptCount val="4"/>
                <c:pt idx="0">
                  <c:v>24 h</c:v>
                </c:pt>
                <c:pt idx="1">
                  <c:v>48 h</c:v>
                </c:pt>
                <c:pt idx="2">
                  <c:v>72 h</c:v>
                </c:pt>
                <c:pt idx="3">
                  <c:v>1 wk</c:v>
                </c:pt>
              </c:strCache>
            </c:strRef>
          </c:cat>
          <c:val>
            <c:numRef>
              <c:f>[Sb03g810Leaves.xls]Mean!$H$2:$K$2</c:f>
              <c:numCache>
                <c:formatCode>General</c:formatCode>
                <c:ptCount val="4"/>
                <c:pt idx="0">
                  <c:v>1.8626188391538467</c:v>
                </c:pt>
                <c:pt idx="1">
                  <c:v>1.1679251536642756</c:v>
                </c:pt>
                <c:pt idx="2">
                  <c:v>1.052379516419123</c:v>
                </c:pt>
                <c:pt idx="3">
                  <c:v>9.9378562589312782</c:v>
                </c:pt>
              </c:numCache>
            </c:numRef>
          </c:val>
        </c:ser>
        <c:ser>
          <c:idx val="3"/>
          <c:order val="1"/>
          <c:tx>
            <c:strRef>
              <c:f>[Sb03g810Leaves.xls]Mean!$G$3</c:f>
              <c:strCache>
                <c:ptCount val="1"/>
                <c:pt idx="0">
                  <c:v>LCP 85-384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[Sb03g810Leaves.xls]Mean!$D$33:$D$36</c:f>
                <c:numCache>
                  <c:formatCode>General</c:formatCode>
                  <c:ptCount val="4"/>
                  <c:pt idx="0">
                    <c:v>0.24052067021947099</c:v>
                  </c:pt>
                  <c:pt idx="1">
                    <c:v>3.307245737517224E-2</c:v>
                  </c:pt>
                  <c:pt idx="2">
                    <c:v>0.3349947837213953</c:v>
                  </c:pt>
                  <c:pt idx="3">
                    <c:v>0.18847181089951795</c:v>
                  </c:pt>
                </c:numCache>
              </c:numRef>
            </c:plus>
          </c:errBars>
          <c:cat>
            <c:strRef>
              <c:f>[Sb03g810Leaves.xls]Mean!$H$1:$K$1</c:f>
              <c:strCache>
                <c:ptCount val="4"/>
                <c:pt idx="0">
                  <c:v>24 h</c:v>
                </c:pt>
                <c:pt idx="1">
                  <c:v>48 h</c:v>
                </c:pt>
                <c:pt idx="2">
                  <c:v>72 h</c:v>
                </c:pt>
                <c:pt idx="3">
                  <c:v>1 wk</c:v>
                </c:pt>
              </c:strCache>
            </c:strRef>
          </c:cat>
          <c:val>
            <c:numRef>
              <c:f>[Sb03g810Leaves.xls]Mean!$H$3:$K$3</c:f>
              <c:numCache>
                <c:formatCode>General</c:formatCode>
                <c:ptCount val="4"/>
                <c:pt idx="0">
                  <c:v>0.15388805569625061</c:v>
                </c:pt>
                <c:pt idx="1">
                  <c:v>0.77992113264334961</c:v>
                </c:pt>
                <c:pt idx="2">
                  <c:v>0.28198921499618063</c:v>
                </c:pt>
                <c:pt idx="3">
                  <c:v>0.463045402073131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680768"/>
        <c:axId val="95699328"/>
      </c:barChart>
      <c:catAx>
        <c:axId val="956807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Time after inocula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95699328"/>
        <c:crosses val="autoZero"/>
        <c:auto val="1"/>
        <c:lblAlgn val="ctr"/>
        <c:lblOffset val="100"/>
        <c:noMultiLvlLbl val="0"/>
      </c:catAx>
      <c:valAx>
        <c:axId val="956993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Relative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956807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6767366579177609"/>
          <c:y val="0.29600357247010789"/>
          <c:w val="0.31357638888888889"/>
          <c:h val="0.15799285505978419"/>
        </c:manualLayout>
      </c:layout>
      <c:overlay val="0"/>
      <c:txPr>
        <a:bodyPr/>
        <a:lstStyle/>
        <a:p>
          <a:pPr>
            <a:defRPr sz="1000" b="0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814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975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048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068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331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429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472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450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798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348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886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620DB-FC21-4AE4-A8D3-79205F8B1560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E6739A-1B7C-4CB1-AA0E-A8A1810A5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965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3479486"/>
              </p:ext>
            </p:extLst>
          </p:nvPr>
        </p:nvGraphicFramePr>
        <p:xfrm>
          <a:off x="152400" y="304800"/>
          <a:ext cx="3581400" cy="220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85800" y="133281"/>
            <a:ext cx="22797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ta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apti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Sb01g035130.1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1427559"/>
              </p:ext>
            </p:extLst>
          </p:nvPr>
        </p:nvGraphicFramePr>
        <p:xfrm>
          <a:off x="4223216" y="571500"/>
          <a:ext cx="3091984" cy="1866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Rectangle 7"/>
          <p:cNvSpPr/>
          <p:nvPr/>
        </p:nvSpPr>
        <p:spPr>
          <a:xfrm>
            <a:off x="4191000" y="133281"/>
            <a:ext cx="356963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PM1 (Resistanc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syringa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culicol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;</a:t>
            </a:r>
          </a:p>
          <a:p>
            <a:r>
              <a:rPr lang="en-US" sz="120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Sb05g008340.1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5253960"/>
              </p:ext>
            </p:extLst>
          </p:nvPr>
        </p:nvGraphicFramePr>
        <p:xfrm>
          <a:off x="2590801" y="3124200"/>
          <a:ext cx="36576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Rectangle 9"/>
          <p:cNvSpPr/>
          <p:nvPr/>
        </p:nvSpPr>
        <p:spPr>
          <a:xfrm>
            <a:off x="2590800" y="2805499"/>
            <a:ext cx="40286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IC1 (Pathogen-infected compatible 1;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b03g1806945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838200" y="5181600"/>
            <a:ext cx="77724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real-time PCR showing temporal changes in the expression of one selected gene from three QTLs in the leaf/meristematic tissues of a leaf scald resistant clone (LCP 85-384) and susceptible clon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C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5-845). RNA was isolated from meristematic tissues at 0 h (control), 24 h, 48 h, 72 h and 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leaf scald inoculation. First strand synthesis, real-time PCR, and fold-change relative expression was performed as described earlier (Baisakh et al. 2012). 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isakh, N.,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manaRao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.V., Rajasekaran, K., Subudhi, P., Galbraith, D.,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on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J. et al. (2012). Enhanced salt stress tolerance of rice plants expressing a vacuolar H+-ATPase subunit c1 (SaVHAc1) gene from a halophyte grass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artina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terniflor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öise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lant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techno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J.10, 453-464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10.1111/j.1467-7652.2012.00678.x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6458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9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ranjan Baisakh</dc:creator>
  <cp:lastModifiedBy>Niranjan Baisakh</cp:lastModifiedBy>
  <cp:revision>6</cp:revision>
  <dcterms:created xsi:type="dcterms:W3CDTF">2018-03-12T16:40:17Z</dcterms:created>
  <dcterms:modified xsi:type="dcterms:W3CDTF">2018-03-12T20:59:28Z</dcterms:modified>
</cp:coreProperties>
</file>